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87" d="100"/>
          <a:sy n="87" d="100"/>
        </p:scale>
        <p:origin x="61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A8CCA-532C-4A35-A4D7-42274C343B5F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F85F9-3156-4CB3-9039-F233F21B7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144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A8CCA-532C-4A35-A4D7-42274C343B5F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F85F9-3156-4CB3-9039-F233F21B7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621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A8CCA-532C-4A35-A4D7-42274C343B5F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F85F9-3156-4CB3-9039-F233F21B7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79014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A8CCA-532C-4A35-A4D7-42274C343B5F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F85F9-3156-4CB3-9039-F233F21B7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0045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A8CCA-532C-4A35-A4D7-42274C343B5F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F85F9-3156-4CB3-9039-F233F21B7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7753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A8CCA-532C-4A35-A4D7-42274C343B5F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F85F9-3156-4CB3-9039-F233F21B7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189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A8CCA-532C-4A35-A4D7-42274C343B5F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F85F9-3156-4CB3-9039-F233F21B7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4724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A8CCA-532C-4A35-A4D7-42274C343B5F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F85F9-3156-4CB3-9039-F233F21B7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2306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A8CCA-532C-4A35-A4D7-42274C343B5F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F85F9-3156-4CB3-9039-F233F21B7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215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A8CCA-532C-4A35-A4D7-42274C343B5F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F85F9-3156-4CB3-9039-F233F21B7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7869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A8CCA-532C-4A35-A4D7-42274C343B5F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AF85F9-3156-4CB3-9039-F233F21B7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7198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1A8CCA-532C-4A35-A4D7-42274C343B5F}" type="datetimeFigureOut">
              <a:rPr lang="en-US" smtClean="0"/>
              <a:t>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AF85F9-3156-4CB3-9039-F233F21B7D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060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73725" y="5574535"/>
            <a:ext cx="113253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 smtClean="0"/>
              <a:t>S3. </a:t>
            </a:r>
            <a:r>
              <a:rPr lang="en-US" dirty="0" smtClean="0"/>
              <a:t>Graph showing the </a:t>
            </a:r>
            <a:r>
              <a:rPr lang="en-US" dirty="0"/>
              <a:t>optimum value of K </a:t>
            </a:r>
            <a:r>
              <a:rPr lang="en-US" dirty="0" smtClean="0"/>
              <a:t>using </a:t>
            </a:r>
            <a:r>
              <a:rPr lang="en-US" dirty="0"/>
              <a:t>STRUCTURE based on </a:t>
            </a:r>
            <a:r>
              <a:rPr lang="en-US" dirty="0" smtClean="0"/>
              <a:t>the </a:t>
            </a:r>
            <a:r>
              <a:rPr lang="en-US" dirty="0"/>
              <a:t>Delta K estimate of </a:t>
            </a:r>
            <a:r>
              <a:rPr lang="en-US" dirty="0" err="1"/>
              <a:t>Evanno</a:t>
            </a:r>
            <a:r>
              <a:rPr lang="en-US" dirty="0"/>
              <a:t> et al. </a:t>
            </a:r>
            <a:r>
              <a:rPr lang="en-US" dirty="0" smtClean="0"/>
              <a:t>(2005).  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/>
          <a:srcRect l="5118" t="21218" r="26726" b="2079"/>
          <a:stretch/>
        </p:blipFill>
        <p:spPr>
          <a:xfrm>
            <a:off x="3329395" y="751098"/>
            <a:ext cx="5533209" cy="42100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75690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Franklin College - University of Georg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rien M. Devos</dc:creator>
  <cp:lastModifiedBy>Katrien M. Devos</cp:lastModifiedBy>
  <cp:revision>3</cp:revision>
  <dcterms:created xsi:type="dcterms:W3CDTF">2019-07-10T01:19:04Z</dcterms:created>
  <dcterms:modified xsi:type="dcterms:W3CDTF">2020-02-08T16:42:01Z</dcterms:modified>
</cp:coreProperties>
</file>